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8CD35EA-A195-49DF-888C-33509FE65B3B}" v="6" dt="2020-02-24T07:04:05.48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15" autoAdjust="0"/>
    <p:restoredTop sz="94660"/>
  </p:normalViewPr>
  <p:slideViewPr>
    <p:cSldViewPr snapToGrid="0" showGuides="1">
      <p:cViewPr varScale="1">
        <p:scale>
          <a:sx n="70" d="100"/>
          <a:sy n="70" d="100"/>
        </p:scale>
        <p:origin x="1314" y="6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nn Meyers" userId="470a02ee-1e65-42af-a6dc-85a5b9f23514" providerId="ADAL" clId="{28CD35EA-A195-49DF-888C-33509FE65B3B}"/>
    <pc:docChg chg="custSel modSld">
      <pc:chgData name="Ann Meyers" userId="470a02ee-1e65-42af-a6dc-85a5b9f23514" providerId="ADAL" clId="{28CD35EA-A195-49DF-888C-33509FE65B3B}" dt="2020-02-24T07:04:37.451" v="18" actId="255"/>
      <pc:docMkLst>
        <pc:docMk/>
      </pc:docMkLst>
      <pc:sldChg chg="addSp delSp modSp">
        <pc:chgData name="Ann Meyers" userId="470a02ee-1e65-42af-a6dc-85a5b9f23514" providerId="ADAL" clId="{28CD35EA-A195-49DF-888C-33509FE65B3B}" dt="2020-02-24T07:04:37.451" v="18" actId="255"/>
        <pc:sldMkLst>
          <pc:docMk/>
          <pc:sldMk cId="2398928671" sldId="256"/>
        </pc:sldMkLst>
        <pc:spChg chg="add mod">
          <ac:chgData name="Ann Meyers" userId="470a02ee-1e65-42af-a6dc-85a5b9f23514" providerId="ADAL" clId="{28CD35EA-A195-49DF-888C-33509FE65B3B}" dt="2020-02-24T07:04:37.451" v="18" actId="255"/>
          <ac:spMkLst>
            <pc:docMk/>
            <pc:sldMk cId="2398928671" sldId="256"/>
            <ac:spMk id="2" creationId="{219CE39A-CBC7-4F88-A7B3-A4B239636EE4}"/>
          </ac:spMkLst>
        </pc:spChg>
        <pc:spChg chg="add del mod">
          <ac:chgData name="Ann Meyers" userId="470a02ee-1e65-42af-a6dc-85a5b9f23514" providerId="ADAL" clId="{28CD35EA-A195-49DF-888C-33509FE65B3B}" dt="2020-02-24T07:01:54.551" v="11" actId="478"/>
          <ac:spMkLst>
            <pc:docMk/>
            <pc:sldMk cId="2398928671" sldId="256"/>
            <ac:spMk id="2" creationId="{541640AC-8A0E-4B1E-AEB9-1D1636254B49}"/>
          </ac:spMkLst>
        </pc:spChg>
        <pc:spChg chg="del mod topLvl">
          <ac:chgData name="Ann Meyers" userId="470a02ee-1e65-42af-a6dc-85a5b9f23514" providerId="ADAL" clId="{28CD35EA-A195-49DF-888C-33509FE65B3B}" dt="2020-02-03T10:54:54.893" v="4" actId="478"/>
          <ac:spMkLst>
            <pc:docMk/>
            <pc:sldMk cId="2398928671" sldId="256"/>
            <ac:spMk id="6" creationId="{0056FCB7-5602-469A-97F9-F264C21DD492}"/>
          </ac:spMkLst>
        </pc:spChg>
        <pc:grpChg chg="add del">
          <ac:chgData name="Ann Meyers" userId="470a02ee-1e65-42af-a6dc-85a5b9f23514" providerId="ADAL" clId="{28CD35EA-A195-49DF-888C-33509FE65B3B}" dt="2020-02-03T10:54:45.286" v="1" actId="165"/>
          <ac:grpSpMkLst>
            <pc:docMk/>
            <pc:sldMk cId="2398928671" sldId="256"/>
            <ac:grpSpMk id="5" creationId="{677B2B6C-22F6-406C-9065-E80527476718}"/>
          </ac:grpSpMkLst>
        </pc:grpChg>
        <pc:grpChg chg="del mod topLvl">
          <ac:chgData name="Ann Meyers" userId="470a02ee-1e65-42af-a6dc-85a5b9f23514" providerId="ADAL" clId="{28CD35EA-A195-49DF-888C-33509FE65B3B}" dt="2020-02-03T10:54:50.589" v="2" actId="478"/>
          <ac:grpSpMkLst>
            <pc:docMk/>
            <pc:sldMk cId="2398928671" sldId="256"/>
            <ac:grpSpMk id="7" creationId="{9FAF5BD5-98C4-4DEC-B7ED-E3C2E54AD1D5}"/>
          </ac:grpSpMkLst>
        </pc:grpChg>
        <pc:picChg chg="mod">
          <ac:chgData name="Ann Meyers" userId="470a02ee-1e65-42af-a6dc-85a5b9f23514" providerId="ADAL" clId="{28CD35EA-A195-49DF-888C-33509FE65B3B}" dt="2020-02-03T10:56:00.064" v="10" actId="1076"/>
          <ac:picMkLst>
            <pc:docMk/>
            <pc:sldMk cId="2398928671" sldId="256"/>
            <ac:picMk id="4" creationId="{2619438B-10A1-4F7C-BF15-9ACDDA1F4867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33E87-BA0E-4690-B2E3-999F269E6205}" type="datetimeFigureOut">
              <a:rPr lang="en-ZA" smtClean="0"/>
              <a:t>2020/02/2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0F2C4-C002-48A0-BDA2-752BF31BD93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6180384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33E87-BA0E-4690-B2E3-999F269E6205}" type="datetimeFigureOut">
              <a:rPr lang="en-ZA" smtClean="0"/>
              <a:t>2020/02/2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0F2C4-C002-48A0-BDA2-752BF31BD93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825434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33E87-BA0E-4690-B2E3-999F269E6205}" type="datetimeFigureOut">
              <a:rPr lang="en-ZA" smtClean="0"/>
              <a:t>2020/02/2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0F2C4-C002-48A0-BDA2-752BF31BD93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3516708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33E87-BA0E-4690-B2E3-999F269E6205}" type="datetimeFigureOut">
              <a:rPr lang="en-ZA" smtClean="0"/>
              <a:t>2020/02/2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0F2C4-C002-48A0-BDA2-752BF31BD93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2083217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33E87-BA0E-4690-B2E3-999F269E6205}" type="datetimeFigureOut">
              <a:rPr lang="en-ZA" smtClean="0"/>
              <a:t>2020/02/2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0F2C4-C002-48A0-BDA2-752BF31BD93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88545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33E87-BA0E-4690-B2E3-999F269E6205}" type="datetimeFigureOut">
              <a:rPr lang="en-ZA" smtClean="0"/>
              <a:t>2020/02/24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0F2C4-C002-48A0-BDA2-752BF31BD93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1666169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33E87-BA0E-4690-B2E3-999F269E6205}" type="datetimeFigureOut">
              <a:rPr lang="en-ZA" smtClean="0"/>
              <a:t>2020/02/24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0F2C4-C002-48A0-BDA2-752BF31BD93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7912714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33E87-BA0E-4690-B2E3-999F269E6205}" type="datetimeFigureOut">
              <a:rPr lang="en-ZA" smtClean="0"/>
              <a:t>2020/02/24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0F2C4-C002-48A0-BDA2-752BF31BD93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3658404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33E87-BA0E-4690-B2E3-999F269E6205}" type="datetimeFigureOut">
              <a:rPr lang="en-ZA" smtClean="0"/>
              <a:t>2020/02/24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0F2C4-C002-48A0-BDA2-752BF31BD93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8660942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33E87-BA0E-4690-B2E3-999F269E6205}" type="datetimeFigureOut">
              <a:rPr lang="en-ZA" smtClean="0"/>
              <a:t>2020/02/24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0F2C4-C002-48A0-BDA2-752BF31BD93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857458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33E87-BA0E-4690-B2E3-999F269E6205}" type="datetimeFigureOut">
              <a:rPr lang="en-ZA" smtClean="0"/>
              <a:t>2020/02/24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0F2C4-C002-48A0-BDA2-752BF31BD93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8896536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833E87-BA0E-4690-B2E3-999F269E6205}" type="datetimeFigureOut">
              <a:rPr lang="en-ZA" smtClean="0"/>
              <a:t>2020/02/2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90F2C4-C002-48A0-BDA2-752BF31BD93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0123294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2619438B-10A1-4F7C-BF15-9ACDDA1F486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52404"/>
            <a:ext cx="6855221" cy="474592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19CE39A-CBC7-4F88-A7B3-A4B239636EE4}"/>
              </a:ext>
            </a:extLst>
          </p:cNvPr>
          <p:cNvSpPr txBox="1"/>
          <p:nvPr/>
        </p:nvSpPr>
        <p:spPr>
          <a:xfrm>
            <a:off x="955973" y="4057163"/>
            <a:ext cx="542971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enotype of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. </a:t>
            </a:r>
            <a:r>
              <a:rPr lang="en-US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nthamiana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ants 3 days after infiltration with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tumefaciens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ncoding human PDI</a:t>
            </a:r>
            <a:endParaRPr lang="en-Z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989286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FA2F3BAF291F44B9BAC9868B50C80F1" ma:contentTypeVersion="13" ma:contentTypeDescription="Create a new document." ma:contentTypeScope="" ma:versionID="bc4a9a0540e0ef972c7ebd2a0284d042">
  <xsd:schema xmlns:xsd="http://www.w3.org/2001/XMLSchema" xmlns:xs="http://www.w3.org/2001/XMLSchema" xmlns:p="http://schemas.microsoft.com/office/2006/metadata/properties" xmlns:ns3="dcca6e4b-f4d1-4c2f-83f7-8a9b9cca29ae" xmlns:ns4="220f49fd-4060-4647-a9a5-4c9032b44770" targetNamespace="http://schemas.microsoft.com/office/2006/metadata/properties" ma:root="true" ma:fieldsID="875b4c7d21ae34cbc3f1277f276c462c" ns3:_="" ns4:_="">
    <xsd:import namespace="dcca6e4b-f4d1-4c2f-83f7-8a9b9cca29ae"/>
    <xsd:import namespace="220f49fd-4060-4647-a9a5-4c9032b44770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cca6e4b-f4d1-4c2f-83f7-8a9b9cca29a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5" nillable="true" ma:displayName="Location" ma:internalName="MediaServiceLocation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20f49fd-4060-4647-a9a5-4c9032b44770" elementFormDefault="qualified">
    <xsd:import namespace="http://schemas.microsoft.com/office/2006/documentManagement/types"/>
    <xsd:import namespace="http://schemas.microsoft.com/office/infopath/2007/PartnerControls"/>
    <xsd:element name="SharedWithUsers" ma:index="16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7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8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AAE2253A-76B1-4F92-A1E6-F27AF8C3283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dcca6e4b-f4d1-4c2f-83f7-8a9b9cca29ae"/>
    <ds:schemaRef ds:uri="220f49fd-4060-4647-a9a5-4c9032b44770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3169CB88-8825-401F-9F77-CFB5A4EB305D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D8647161-C4DA-4F91-B621-443D3C4FDC09}">
  <ds:schemaRefs>
    <ds:schemaRef ds:uri="http://purl.org/dc/terms/"/>
    <ds:schemaRef ds:uri="http://schemas.openxmlformats.org/package/2006/metadata/core-properties"/>
    <ds:schemaRef ds:uri="http://purl.org/dc/dcmitype/"/>
    <ds:schemaRef ds:uri="http://schemas.microsoft.com/office/infopath/2007/PartnerControls"/>
    <ds:schemaRef ds:uri="http://schemas.microsoft.com/office/2006/documentManagement/types"/>
    <ds:schemaRef ds:uri="http://purl.org/dc/elements/1.1/"/>
    <ds:schemaRef ds:uri="http://schemas.microsoft.com/office/2006/metadata/properties"/>
    <ds:schemaRef ds:uri="220f49fd-4060-4647-a9a5-4c9032b44770"/>
    <ds:schemaRef ds:uri="dcca6e4b-f4d1-4c2f-83f7-8a9b9cca29ae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17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 Meyers</dc:creator>
  <cp:lastModifiedBy>Ann Meyers</cp:lastModifiedBy>
  <cp:revision>1</cp:revision>
  <dcterms:created xsi:type="dcterms:W3CDTF">2020-02-03T10:31:39Z</dcterms:created>
  <dcterms:modified xsi:type="dcterms:W3CDTF">2020-02-24T07:04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FA2F3BAF291F44B9BAC9868B50C80F1</vt:lpwstr>
  </property>
</Properties>
</file>